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1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45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41E03E3-DD17-405A-B182-0592E28A50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4FEAF0A-9B2D-4A37-819A-5CEDB2041F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A965E6-09BF-4BF8-83E0-E8F23FCF87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ED31C96-BD5E-460D-9588-C6C1E38830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27FE706-F771-489B-8C16-ABB2982FA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5621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D4A8460-A0CE-43CC-A7F0-F877C234DE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6A5FAC3-472E-4EF3-9151-FEB697CD11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AA58F36-CECF-448F-9798-72D3047E7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DBB7394-11F1-4D85-BD8A-637E6D06B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02B92E2-AB86-4244-982E-FB812DC18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088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476C544-996B-42F4-8EF6-53891FAA53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E57C503-C48D-4CB7-A7EA-629DABAE51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B007711-7125-40DB-BF30-07B3764E4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99542DF-0208-4A98-927A-DA7A2D0BF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C86AAC4-2CC8-4A05-98F1-6709DBF99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6081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5F8910C-6DD5-480B-A612-CC3FE1A181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7732216-60A2-430F-9747-F31AE6AC84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8A11E19-723A-4EF2-A09D-11C6B8047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A787A8C-A861-48E6-8D03-416441882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4EE99D8-DA62-454C-879C-BAA59EBFFD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39964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C4F33F1-7248-4B12-B755-2EF5AE7638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2572569-1457-48B0-942C-B7A7E00316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44C6728-BC24-435A-A31D-F88000ED7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B975FE5-7230-46C0-8D3A-B850AEDA8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4469A33-5809-4A85-B289-20A0D970B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1475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F0F533E-537F-4464-A82C-ECCDB0D0EA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9FF51AE-D24B-4E71-BF7D-EB36237DA1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732568C-6557-44B7-9A35-83FAF4CA45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488205A-4CA7-4CAA-97FA-FC6CDA7A6B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6298386-371B-4CEE-A3F0-C209A1CCAE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EB525E0-BFF0-4CEB-8AFA-E2470EC05F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8474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2CB29A9-5DEB-4449-9881-070A6FDB9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71899D-2B06-4822-B604-4531FE1D0C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CAFA875-7E58-428A-BA21-62A5CC9BF0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71C4B2D6-1387-4128-BD0E-406C32FD91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6A134217-8641-4DBD-BED0-3FC0F9E3BB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0F3E7F3-6DF8-479A-9E83-0EF9A9719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AA3BC1C-94E3-445F-83CB-ED8C22E78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D777EB98-13AF-49F1-85F1-6E70B6AC4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551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B3C7F0-5DDB-480E-857A-F105DB0105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D086671D-AFEF-4E1C-B958-4DE5BD09C1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3550BE7-B455-46DA-B0FA-5615DF009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CB95503-55C9-4714-8819-6BEE66838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6607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05C201C4-DB7D-4A52-BEA8-E7A7B29FCF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A0AC50C-0378-4447-8A44-E19CFF33B8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C2459AFA-B837-4DB4-8180-F307E14B8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53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581D733-EBB2-4E80-BC97-15F1BA6529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444D97F-77E6-4BB1-B6BD-4215071FA0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A2C5100-D7F4-42E3-B678-B168198432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F48A14C-1C72-40B9-83F0-9236F7F8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E442D42-9DB7-4001-B0E2-3668903AF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EA567BC-F63F-461A-88BA-5E8BAD480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6676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EE92AAB-E69E-4E32-B31A-39D21B3918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68EF528-BD53-442E-9410-4453122FF7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35C54EF-71C6-4EF0-B882-389A0DB1F8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B98AB7F-23AE-4BAF-B490-73EA5A48E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8A44371-1B12-4229-A4B0-406B226B5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D98358C-A6E6-41E7-8361-95AEF6283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8054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7F88447-1B33-4420-9539-64912FBDBD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454FE5C-599C-44A0-AFA0-447035E765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46CA4C8-2EAB-4182-8ED1-AA0D66A4D5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70A81-FB00-4711-BACA-798F88D39946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03BDC5A-B842-4A2C-B02B-2B19C187E2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4874A8A-7317-4BB4-A114-0D2E93954B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8586B-C82B-40E8-8289-C76F5B6A56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55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BFD87D42-6075-4901-8E1F-6A5F3E8E9C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1426A82-D3D4-44A2-8F01-1BB5D2C45D18}"/>
              </a:ext>
            </a:extLst>
          </p:cNvPr>
          <p:cNvSpPr/>
          <p:nvPr/>
        </p:nvSpPr>
        <p:spPr>
          <a:xfrm>
            <a:off x="4389931" y="372543"/>
            <a:ext cx="3260128" cy="2277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i="1" dirty="0" err="1">
                <a:solidFill>
                  <a:schemeClr val="tx1"/>
                </a:solidFill>
              </a:rPr>
              <a:t>tle</a:t>
            </a:r>
            <a:r>
              <a:rPr lang="fr-FR" i="1" dirty="0">
                <a:solidFill>
                  <a:schemeClr val="tx1"/>
                </a:solidFill>
              </a:rPr>
              <a:t> </a:t>
            </a:r>
            <a:r>
              <a:rPr lang="fr-FR" dirty="0">
                <a:solidFill>
                  <a:schemeClr val="tx1"/>
                </a:solidFill>
              </a:rPr>
              <a:t>(Lipase) </a:t>
            </a:r>
            <a:r>
              <a:rPr lang="fr-FR" dirty="0" err="1">
                <a:solidFill>
                  <a:schemeClr val="tx1"/>
                </a:solidFill>
              </a:rPr>
              <a:t>nucleotide</a:t>
            </a:r>
            <a:r>
              <a:rPr lang="fr-FR" dirty="0">
                <a:solidFill>
                  <a:schemeClr val="tx1"/>
                </a:solidFill>
              </a:rPr>
              <a:t> distance</a:t>
            </a:r>
          </a:p>
        </p:txBody>
      </p:sp>
      <p:cxnSp>
        <p:nvCxnSpPr>
          <p:cNvPr id="5" name="Connecteur droit avec flèche 4">
            <a:extLst>
              <a:ext uri="{FF2B5EF4-FFF2-40B4-BE49-F238E27FC236}">
                <a16:creationId xmlns:a16="http://schemas.microsoft.com/office/drawing/2014/main" id="{0A8481F4-18FB-41EC-8718-A6C9E1CD1F0F}"/>
              </a:ext>
            </a:extLst>
          </p:cNvPr>
          <p:cNvCxnSpPr>
            <a:cxnSpLocks/>
          </p:cNvCxnSpPr>
          <p:nvPr/>
        </p:nvCxnSpPr>
        <p:spPr>
          <a:xfrm flipV="1">
            <a:off x="2425174" y="1707302"/>
            <a:ext cx="1722931" cy="8124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ZoneTexte 5">
            <a:extLst>
              <a:ext uri="{FF2B5EF4-FFF2-40B4-BE49-F238E27FC236}">
                <a16:creationId xmlns:a16="http://schemas.microsoft.com/office/drawing/2014/main" id="{903DF6C9-504E-42B9-826D-FF99DCE24F72}"/>
              </a:ext>
            </a:extLst>
          </p:cNvPr>
          <p:cNvSpPr txBox="1"/>
          <p:nvPr/>
        </p:nvSpPr>
        <p:spPr>
          <a:xfrm>
            <a:off x="1259793" y="2223833"/>
            <a:ext cx="1225704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/>
              <a:t>tle</a:t>
            </a:r>
            <a:r>
              <a:rPr lang="fr-FR" sz="1600" b="1" dirty="0"/>
              <a:t>_M2</a:t>
            </a:r>
          </a:p>
          <a:p>
            <a:pPr algn="ctr"/>
            <a:r>
              <a:rPr lang="fr-FR" sz="1400" dirty="0"/>
              <a:t>% of </a:t>
            </a:r>
            <a:r>
              <a:rPr lang="fr-FR" sz="1400" dirty="0" err="1"/>
              <a:t>identity</a:t>
            </a:r>
            <a:r>
              <a:rPr lang="fr-FR" sz="1400" dirty="0"/>
              <a:t>  Max-Min [100-97%]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6933A6E-D402-4072-AF71-99BCA48E7BB2}"/>
              </a:ext>
            </a:extLst>
          </p:cNvPr>
          <p:cNvSpPr/>
          <p:nvPr/>
        </p:nvSpPr>
        <p:spPr>
          <a:xfrm>
            <a:off x="4759725" y="1931746"/>
            <a:ext cx="3850192" cy="386954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B052FB4-7667-4794-8D56-9D1818310D31}"/>
              </a:ext>
            </a:extLst>
          </p:cNvPr>
          <p:cNvSpPr/>
          <p:nvPr/>
        </p:nvSpPr>
        <p:spPr>
          <a:xfrm>
            <a:off x="4148105" y="1338294"/>
            <a:ext cx="585533" cy="5934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685F033-24CF-466D-B9B8-7444BDF7FC54}"/>
              </a:ext>
            </a:extLst>
          </p:cNvPr>
          <p:cNvSpPr/>
          <p:nvPr/>
        </p:nvSpPr>
        <p:spPr>
          <a:xfrm>
            <a:off x="3778311" y="969285"/>
            <a:ext cx="369794" cy="36900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2910D11-80C7-47DE-84C3-2DEBF6B1511B}"/>
              </a:ext>
            </a:extLst>
          </p:cNvPr>
          <p:cNvSpPr/>
          <p:nvPr/>
        </p:nvSpPr>
        <p:spPr>
          <a:xfrm>
            <a:off x="3414171" y="600276"/>
            <a:ext cx="369794" cy="36900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3" name="Connecteur droit avec flèche 12">
            <a:extLst>
              <a:ext uri="{FF2B5EF4-FFF2-40B4-BE49-F238E27FC236}">
                <a16:creationId xmlns:a16="http://schemas.microsoft.com/office/drawing/2014/main" id="{21D1F4E1-1065-403B-94D1-A94F4D3E786A}"/>
              </a:ext>
            </a:extLst>
          </p:cNvPr>
          <p:cNvCxnSpPr>
            <a:cxnSpLocks/>
          </p:cNvCxnSpPr>
          <p:nvPr/>
        </p:nvCxnSpPr>
        <p:spPr>
          <a:xfrm flipV="1">
            <a:off x="1259793" y="1176645"/>
            <a:ext cx="2500676" cy="55046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>
            <a:extLst>
              <a:ext uri="{FF2B5EF4-FFF2-40B4-BE49-F238E27FC236}">
                <a16:creationId xmlns:a16="http://schemas.microsoft.com/office/drawing/2014/main" id="{BDD9CF8A-AD13-4436-8D7D-7A6C10C701B9}"/>
              </a:ext>
            </a:extLst>
          </p:cNvPr>
          <p:cNvCxnSpPr>
            <a:cxnSpLocks/>
          </p:cNvCxnSpPr>
          <p:nvPr/>
        </p:nvCxnSpPr>
        <p:spPr>
          <a:xfrm flipV="1">
            <a:off x="2053063" y="698929"/>
            <a:ext cx="1296307" cy="5663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ZoneTexte 17">
            <a:extLst>
              <a:ext uri="{FF2B5EF4-FFF2-40B4-BE49-F238E27FC236}">
                <a16:creationId xmlns:a16="http://schemas.microsoft.com/office/drawing/2014/main" id="{21164965-9179-4788-821E-3889014FEE3D}"/>
              </a:ext>
            </a:extLst>
          </p:cNvPr>
          <p:cNvSpPr txBox="1"/>
          <p:nvPr/>
        </p:nvSpPr>
        <p:spPr>
          <a:xfrm>
            <a:off x="1356098" y="3615652"/>
            <a:ext cx="1225704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/>
              <a:t>tle</a:t>
            </a:r>
            <a:r>
              <a:rPr lang="fr-FR" sz="1600" b="1" dirty="0"/>
              <a:t>_M1</a:t>
            </a:r>
          </a:p>
          <a:p>
            <a:pPr algn="ctr"/>
            <a:r>
              <a:rPr lang="fr-FR" sz="1400" dirty="0"/>
              <a:t>% of </a:t>
            </a:r>
            <a:r>
              <a:rPr lang="fr-FR" sz="1400" dirty="0" err="1"/>
              <a:t>identity</a:t>
            </a:r>
            <a:r>
              <a:rPr lang="fr-FR" sz="1400" dirty="0"/>
              <a:t>  Max-Min [100-85%]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639863C4-5DEF-4C3F-8B54-6040452A2602}"/>
              </a:ext>
            </a:extLst>
          </p:cNvPr>
          <p:cNvSpPr txBox="1"/>
          <p:nvPr/>
        </p:nvSpPr>
        <p:spPr>
          <a:xfrm>
            <a:off x="130394" y="1466004"/>
            <a:ext cx="1225704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/>
              <a:t>tle</a:t>
            </a:r>
            <a:r>
              <a:rPr lang="fr-FR" sz="1600" b="1" dirty="0"/>
              <a:t>_M3</a:t>
            </a:r>
          </a:p>
          <a:p>
            <a:pPr algn="ctr"/>
            <a:r>
              <a:rPr lang="fr-FR" sz="1400" dirty="0"/>
              <a:t>% of </a:t>
            </a:r>
            <a:r>
              <a:rPr lang="fr-FR" sz="1400" dirty="0" err="1"/>
              <a:t>identity</a:t>
            </a:r>
            <a:r>
              <a:rPr lang="fr-FR" sz="1400" dirty="0"/>
              <a:t>  Max-Min [100-88%]</a:t>
            </a:r>
          </a:p>
        </p:txBody>
      </p:sp>
      <p:cxnSp>
        <p:nvCxnSpPr>
          <p:cNvPr id="21" name="Connecteur droit avec flèche 20">
            <a:extLst>
              <a:ext uri="{FF2B5EF4-FFF2-40B4-BE49-F238E27FC236}">
                <a16:creationId xmlns:a16="http://schemas.microsoft.com/office/drawing/2014/main" id="{9E8B9229-538D-4F1F-B555-7902CB4EE439}"/>
              </a:ext>
            </a:extLst>
          </p:cNvPr>
          <p:cNvCxnSpPr>
            <a:cxnSpLocks/>
          </p:cNvCxnSpPr>
          <p:nvPr/>
        </p:nvCxnSpPr>
        <p:spPr>
          <a:xfrm flipV="1">
            <a:off x="2485497" y="3209440"/>
            <a:ext cx="2248141" cy="80521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>
            <a:extLst>
              <a:ext uri="{FF2B5EF4-FFF2-40B4-BE49-F238E27FC236}">
                <a16:creationId xmlns:a16="http://schemas.microsoft.com/office/drawing/2014/main" id="{BA5593E5-726A-4C16-AC28-641B0AE4A60E}"/>
              </a:ext>
            </a:extLst>
          </p:cNvPr>
          <p:cNvSpPr txBox="1"/>
          <p:nvPr/>
        </p:nvSpPr>
        <p:spPr>
          <a:xfrm>
            <a:off x="751748" y="446956"/>
            <a:ext cx="1697819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/>
              <a:t>tle</a:t>
            </a:r>
            <a:r>
              <a:rPr lang="fr-FR" sz="1600" b="1" dirty="0"/>
              <a:t>_M4</a:t>
            </a:r>
          </a:p>
          <a:p>
            <a:pPr algn="ctr"/>
            <a:r>
              <a:rPr lang="fr-FR" sz="1400" dirty="0"/>
              <a:t>% of </a:t>
            </a:r>
            <a:r>
              <a:rPr lang="fr-FR" sz="1400" dirty="0" err="1"/>
              <a:t>identity</a:t>
            </a:r>
            <a:endParaRPr lang="fr-FR" sz="1400" dirty="0"/>
          </a:p>
          <a:p>
            <a:pPr algn="ctr"/>
            <a:r>
              <a:rPr lang="fr-FR" sz="1400" dirty="0"/>
              <a:t>Max-Min</a:t>
            </a:r>
          </a:p>
          <a:p>
            <a:pPr algn="ctr"/>
            <a:r>
              <a:rPr lang="fr-FR" sz="1400" dirty="0"/>
              <a:t>[100-92%]</a:t>
            </a:r>
          </a:p>
        </p:txBody>
      </p:sp>
      <p:grpSp>
        <p:nvGrpSpPr>
          <p:cNvPr id="7" name="Groupe 6">
            <a:extLst>
              <a:ext uri="{FF2B5EF4-FFF2-40B4-BE49-F238E27FC236}">
                <a16:creationId xmlns:a16="http://schemas.microsoft.com/office/drawing/2014/main" id="{F87617AD-6F14-49F0-AF73-3379F878DE05}"/>
              </a:ext>
            </a:extLst>
          </p:cNvPr>
          <p:cNvGrpSpPr/>
          <p:nvPr/>
        </p:nvGrpSpPr>
        <p:grpSpPr>
          <a:xfrm>
            <a:off x="3414171" y="5801293"/>
            <a:ext cx="5195746" cy="684164"/>
            <a:chOff x="3414171" y="5801293"/>
            <a:chExt cx="5195746" cy="684164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B3D548F4-35B1-4E98-B264-0ECE4622ABA1}"/>
                </a:ext>
              </a:extLst>
            </p:cNvPr>
            <p:cNvSpPr/>
            <p:nvPr/>
          </p:nvSpPr>
          <p:spPr>
            <a:xfrm>
              <a:off x="4759725" y="5801293"/>
              <a:ext cx="2890334" cy="684164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150E36E3-55DC-44E9-8AB3-0B72DC314E67}"/>
                </a:ext>
              </a:extLst>
            </p:cNvPr>
            <p:cNvSpPr/>
            <p:nvPr/>
          </p:nvSpPr>
          <p:spPr>
            <a:xfrm>
              <a:off x="7644679" y="5801293"/>
              <a:ext cx="617000" cy="684164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47629C5E-281C-48B8-AEEF-75BE9449A4EF}"/>
                </a:ext>
              </a:extLst>
            </p:cNvPr>
            <p:cNvSpPr/>
            <p:nvPr/>
          </p:nvSpPr>
          <p:spPr>
            <a:xfrm>
              <a:off x="8261679" y="5801293"/>
              <a:ext cx="348238" cy="684164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CD7A47AA-9D25-43CA-8B35-FD4C85975A3D}"/>
                </a:ext>
              </a:extLst>
            </p:cNvPr>
            <p:cNvSpPr/>
            <p:nvPr/>
          </p:nvSpPr>
          <p:spPr>
            <a:xfrm>
              <a:off x="3554361" y="5801293"/>
              <a:ext cx="1205364" cy="684164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999738BF-DFCC-4BBB-B27E-76DB3BD20FAE}"/>
                </a:ext>
              </a:extLst>
            </p:cNvPr>
            <p:cNvSpPr/>
            <p:nvPr/>
          </p:nvSpPr>
          <p:spPr>
            <a:xfrm>
              <a:off x="3414171" y="5801293"/>
              <a:ext cx="140190" cy="684164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5" name="Groupe 24">
            <a:extLst>
              <a:ext uri="{FF2B5EF4-FFF2-40B4-BE49-F238E27FC236}">
                <a16:creationId xmlns:a16="http://schemas.microsoft.com/office/drawing/2014/main" id="{3BC8CD03-B87A-4D05-9CBB-8D75B68ABDF3}"/>
              </a:ext>
            </a:extLst>
          </p:cNvPr>
          <p:cNvGrpSpPr/>
          <p:nvPr/>
        </p:nvGrpSpPr>
        <p:grpSpPr>
          <a:xfrm rot="5400000">
            <a:off x="490306" y="2848693"/>
            <a:ext cx="5195746" cy="684164"/>
            <a:chOff x="3414171" y="5801293"/>
            <a:chExt cx="5195746" cy="684164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81FEA512-39BA-4612-9E63-81D8E7E8D49B}"/>
                </a:ext>
              </a:extLst>
            </p:cNvPr>
            <p:cNvSpPr/>
            <p:nvPr/>
          </p:nvSpPr>
          <p:spPr>
            <a:xfrm>
              <a:off x="4759725" y="5801293"/>
              <a:ext cx="2890334" cy="684164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16C1756A-015A-4846-9D37-3D7AE092A78A}"/>
                </a:ext>
              </a:extLst>
            </p:cNvPr>
            <p:cNvSpPr/>
            <p:nvPr/>
          </p:nvSpPr>
          <p:spPr>
            <a:xfrm>
              <a:off x="7644679" y="5801293"/>
              <a:ext cx="617000" cy="684164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F804131B-069E-442A-AF3B-24A1857D494F}"/>
                </a:ext>
              </a:extLst>
            </p:cNvPr>
            <p:cNvSpPr/>
            <p:nvPr/>
          </p:nvSpPr>
          <p:spPr>
            <a:xfrm>
              <a:off x="8261679" y="5801293"/>
              <a:ext cx="348238" cy="684164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5A68F900-CB0D-4E14-9599-8BB4A080D0E4}"/>
                </a:ext>
              </a:extLst>
            </p:cNvPr>
            <p:cNvSpPr/>
            <p:nvPr/>
          </p:nvSpPr>
          <p:spPr>
            <a:xfrm>
              <a:off x="3554361" y="5801293"/>
              <a:ext cx="1205364" cy="684164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9D0061B6-ED3E-4C97-AE5B-E0918067BA51}"/>
                </a:ext>
              </a:extLst>
            </p:cNvPr>
            <p:cNvSpPr/>
            <p:nvPr/>
          </p:nvSpPr>
          <p:spPr>
            <a:xfrm>
              <a:off x="3414171" y="5801293"/>
              <a:ext cx="140190" cy="684164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31" name="Groupe 30">
            <a:extLst>
              <a:ext uri="{FF2B5EF4-FFF2-40B4-BE49-F238E27FC236}">
                <a16:creationId xmlns:a16="http://schemas.microsoft.com/office/drawing/2014/main" id="{47C82DD5-EC3D-4EC1-8CD6-4A07BFCF39B2}"/>
              </a:ext>
            </a:extLst>
          </p:cNvPr>
          <p:cNvGrpSpPr/>
          <p:nvPr/>
        </p:nvGrpSpPr>
        <p:grpSpPr>
          <a:xfrm>
            <a:off x="9344212" y="273739"/>
            <a:ext cx="2973294" cy="941438"/>
            <a:chOff x="9344212" y="273739"/>
            <a:chExt cx="2973294" cy="941438"/>
          </a:xfrm>
        </p:grpSpPr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D4657B34-2F5E-4945-ABBD-47802CD39D7F}"/>
                </a:ext>
              </a:extLst>
            </p:cNvPr>
            <p:cNvSpPr txBox="1"/>
            <p:nvPr/>
          </p:nvSpPr>
          <p:spPr>
            <a:xfrm>
              <a:off x="9705788" y="273739"/>
              <a:ext cx="23509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morganii</a:t>
              </a:r>
              <a:r>
                <a:rPr lang="en-US" sz="14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subsp. </a:t>
              </a:r>
              <a:r>
                <a:rPr lang="en-US" sz="1400" i="1" dirty="0">
                  <a:solidFill>
                    <a:srgbClr val="1F1F1F"/>
                  </a:solidFill>
                  <a:ea typeface="Times New Roman" panose="02020603050405020304" pitchFamily="18" charset="0"/>
                </a:rPr>
                <a:t>morganii</a:t>
              </a:r>
              <a:endParaRPr lang="fr-FR" sz="1400" dirty="0"/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FA98CD6C-3D2D-4C52-AC34-51FD8CF6CC2E}"/>
                </a:ext>
              </a:extLst>
            </p:cNvPr>
            <p:cNvSpPr txBox="1"/>
            <p:nvPr/>
          </p:nvSpPr>
          <p:spPr>
            <a:xfrm>
              <a:off x="9705788" y="609776"/>
              <a:ext cx="26117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morganii</a:t>
              </a:r>
              <a:r>
                <a:rPr lang="en-US" sz="14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subsp. </a:t>
              </a:r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intermedius</a:t>
              </a:r>
              <a:endParaRPr lang="fr-FR" sz="1400" i="1" dirty="0"/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43F592DA-C358-406D-9445-A675BE31E64B}"/>
                </a:ext>
              </a:extLst>
            </p:cNvPr>
            <p:cNvSpPr txBox="1"/>
            <p:nvPr/>
          </p:nvSpPr>
          <p:spPr>
            <a:xfrm>
              <a:off x="9705788" y="907400"/>
              <a:ext cx="26117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</a:t>
              </a:r>
              <a:r>
                <a:rPr lang="en-US" sz="1400" i="1" dirty="0" err="1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sibonii</a:t>
              </a:r>
              <a:endParaRPr lang="fr-FR" sz="1400" dirty="0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3A2BFE6A-3267-432F-B6BF-C42DA8648CC3}"/>
                </a:ext>
              </a:extLst>
            </p:cNvPr>
            <p:cNvSpPr/>
            <p:nvPr/>
          </p:nvSpPr>
          <p:spPr>
            <a:xfrm>
              <a:off x="9357375" y="962486"/>
              <a:ext cx="348413" cy="234709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17629E63-CB3B-4DED-8F12-5C522D04049C}"/>
                </a:ext>
              </a:extLst>
            </p:cNvPr>
            <p:cNvSpPr/>
            <p:nvPr/>
          </p:nvSpPr>
          <p:spPr>
            <a:xfrm>
              <a:off x="9357375" y="625609"/>
              <a:ext cx="348413" cy="234709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A19B00C3-E04C-441C-93A6-50669DE1EC5F}"/>
                </a:ext>
              </a:extLst>
            </p:cNvPr>
            <p:cNvSpPr/>
            <p:nvPr/>
          </p:nvSpPr>
          <p:spPr>
            <a:xfrm>
              <a:off x="9344212" y="310272"/>
              <a:ext cx="348413" cy="234709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5983822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61</Words>
  <Application>Microsoft Macintosh PowerPoint</Application>
  <PresentationFormat>Grand écran</PresentationFormat>
  <Paragraphs>1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thilde Duque</dc:creator>
  <cp:lastModifiedBy>DORTET Laurent</cp:lastModifiedBy>
  <cp:revision>9</cp:revision>
  <dcterms:created xsi:type="dcterms:W3CDTF">2025-09-17T12:07:48Z</dcterms:created>
  <dcterms:modified xsi:type="dcterms:W3CDTF">2025-12-24T14:13:31Z</dcterms:modified>
</cp:coreProperties>
</file>